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5294313" cy="8458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258" autoAdjust="0"/>
  </p:normalViewPr>
  <p:slideViewPr>
    <p:cSldViewPr snapToGrid="0" snapToObjects="1" showGuides="1">
      <p:cViewPr>
        <p:scale>
          <a:sx n="100" d="100"/>
          <a:sy n="100" d="100"/>
        </p:scale>
        <p:origin x="-2456" y="64"/>
      </p:cViewPr>
      <p:guideLst>
        <p:guide orient="horz" pos="3363"/>
        <p:guide pos="73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D30E6C-D614-F943-B9FB-96FF9C305C76}" type="datetimeFigureOut">
              <a:rPr lang="en-US" smtClean="0"/>
              <a:t>02/06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5850" y="685800"/>
            <a:ext cx="21463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AE3C1F-31D8-044F-B83C-1E5B008CC4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5380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CAE3C1F-31D8-044F-B83C-1E5B008CC42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6035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97074" y="2627527"/>
            <a:ext cx="4500166" cy="1813031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94149" y="4792980"/>
            <a:ext cx="3706019" cy="21615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504CA-262B-EE48-AA72-BA88D616B298}" type="datetimeFigureOut">
              <a:rPr lang="en-US" smtClean="0"/>
              <a:t>02/0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F605-37DF-774D-BB90-305F2EADC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2923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504CA-262B-EE48-AA72-BA88D616B298}" type="datetimeFigureOut">
              <a:rPr lang="en-US" smtClean="0"/>
              <a:t>02/0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F605-37DF-774D-BB90-305F2EADC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851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222509" y="417040"/>
            <a:ext cx="689364" cy="8900689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53501" y="417040"/>
            <a:ext cx="1980771" cy="8900689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504CA-262B-EE48-AA72-BA88D616B298}" type="datetimeFigureOut">
              <a:rPr lang="en-US" smtClean="0"/>
              <a:t>02/0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F605-37DF-774D-BB90-305F2EADC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4323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504CA-262B-EE48-AA72-BA88D616B298}" type="datetimeFigureOut">
              <a:rPr lang="en-US" smtClean="0"/>
              <a:t>02/0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F605-37DF-774D-BB90-305F2EADC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066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8214" y="5435180"/>
            <a:ext cx="4500166" cy="167989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8214" y="3584949"/>
            <a:ext cx="4500166" cy="185023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504CA-262B-EE48-AA72-BA88D616B298}" type="datetimeFigureOut">
              <a:rPr lang="en-US" smtClean="0"/>
              <a:t>02/0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F605-37DF-774D-BB90-305F2EADC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607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3499" y="2433691"/>
            <a:ext cx="1334608" cy="68840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76347" y="2433691"/>
            <a:ext cx="1335527" cy="68840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504CA-262B-EE48-AA72-BA88D616B298}" type="datetimeFigureOut">
              <a:rPr lang="en-US" smtClean="0"/>
              <a:t>02/0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F605-37DF-774D-BB90-305F2EADC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901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4716" y="338720"/>
            <a:ext cx="4764882" cy="14097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64716" y="1893306"/>
            <a:ext cx="2339241" cy="78904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4716" y="2682346"/>
            <a:ext cx="2339241" cy="487325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689438" y="1893306"/>
            <a:ext cx="2340160" cy="78904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689438" y="2682346"/>
            <a:ext cx="2340160" cy="487325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504CA-262B-EE48-AA72-BA88D616B298}" type="datetimeFigureOut">
              <a:rPr lang="en-US" smtClean="0"/>
              <a:t>02/06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F605-37DF-774D-BB90-305F2EADC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721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504CA-262B-EE48-AA72-BA88D616B298}" type="datetimeFigureOut">
              <a:rPr lang="en-US" smtClean="0"/>
              <a:t>02/06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F605-37DF-774D-BB90-305F2EADC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406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504CA-262B-EE48-AA72-BA88D616B298}" type="datetimeFigureOut">
              <a:rPr lang="en-US" smtClean="0"/>
              <a:t>02/06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F605-37DF-774D-BB90-305F2EADC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781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4716" y="336763"/>
            <a:ext cx="1741793" cy="143319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069929" y="336765"/>
            <a:ext cx="2959668" cy="721883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64716" y="1769957"/>
            <a:ext cx="1741793" cy="578564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504CA-262B-EE48-AA72-BA88D616B298}" type="datetimeFigureOut">
              <a:rPr lang="en-US" smtClean="0"/>
              <a:t>02/0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F605-37DF-774D-BB90-305F2EADC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228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37722" y="5920740"/>
            <a:ext cx="3176588" cy="69897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037722" y="755756"/>
            <a:ext cx="3176588" cy="507492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37722" y="6619717"/>
            <a:ext cx="3176588" cy="9926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504CA-262B-EE48-AA72-BA88D616B298}" type="datetimeFigureOut">
              <a:rPr lang="en-US" smtClean="0"/>
              <a:t>02/0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21F605-37DF-774D-BB90-305F2EADC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64716" y="338720"/>
            <a:ext cx="4764882" cy="14097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64716" y="1973583"/>
            <a:ext cx="4764882" cy="558202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64716" y="7839501"/>
            <a:ext cx="1235340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5504CA-262B-EE48-AA72-BA88D616B298}" type="datetimeFigureOut">
              <a:rPr lang="en-US" smtClean="0"/>
              <a:t>02/0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808891" y="7839501"/>
            <a:ext cx="1676532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794258" y="7839501"/>
            <a:ext cx="1235340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21F605-37DF-774D-BB90-305F2EADC7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515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6" Type="http://schemas.openxmlformats.org/officeDocument/2006/relationships/image" Target="../media/image4.emf"/><Relationship Id="rId7" Type="http://schemas.openxmlformats.org/officeDocument/2006/relationships/image" Target="../media/image5.emf"/><Relationship Id="rId8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t="17496"/>
          <a:stretch/>
        </p:blipFill>
        <p:spPr>
          <a:xfrm>
            <a:off x="499387" y="731050"/>
            <a:ext cx="3508493" cy="216455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644652" y="513146"/>
            <a:ext cx="641867" cy="21544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800" b="1" dirty="0" smtClean="0">
                <a:latin typeface="Arial"/>
                <a:cs typeface="Arial"/>
              </a:rPr>
              <a:t>DAPI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542614" y="513146"/>
            <a:ext cx="556802" cy="21544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800" b="1" dirty="0" smtClean="0">
                <a:latin typeface="Arial"/>
                <a:cs typeface="Arial"/>
              </a:rPr>
              <a:t>SF1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268289" y="513434"/>
            <a:ext cx="831224" cy="21544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800" b="1" dirty="0" smtClean="0">
                <a:latin typeface="Arial"/>
                <a:cs typeface="Arial"/>
              </a:rPr>
              <a:t>KISS1R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122541" y="511049"/>
            <a:ext cx="837658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800" b="1" dirty="0" smtClean="0">
                <a:latin typeface="Arial"/>
                <a:cs typeface="Arial"/>
              </a:rPr>
              <a:t>MERGE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75607" y="726492"/>
            <a:ext cx="3085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/>
                <a:cs typeface="Arial"/>
              </a:rPr>
              <a:t>(a)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69257" y="1501192"/>
            <a:ext cx="3085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/>
                <a:cs typeface="Arial"/>
              </a:rPr>
              <a:t>(b)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75607" y="2174292"/>
            <a:ext cx="3085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/>
                <a:cs typeface="Arial"/>
              </a:rPr>
              <a:t>(c)</a:t>
            </a:r>
            <a:endParaRPr lang="en-US" sz="800" b="1" dirty="0">
              <a:latin typeface="Arial"/>
              <a:cs typeface="Arial"/>
            </a:endParaRP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5513" y="3618136"/>
            <a:ext cx="1571904" cy="1069975"/>
          </a:xfrm>
          <a:prstGeom prst="rect">
            <a:avLst/>
          </a:prstGeom>
        </p:spPr>
      </p:pic>
      <p:sp>
        <p:nvSpPr>
          <p:cNvPr id="51" name="TextBox 50"/>
          <p:cNvSpPr txBox="1"/>
          <p:nvPr/>
        </p:nvSpPr>
        <p:spPr>
          <a:xfrm>
            <a:off x="734011" y="4457731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734023" y="4283093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1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734953" y="4111643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2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735013" y="3940193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3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736337" y="3765586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4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33162" y="3592772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5</a:t>
            </a:r>
          </a:p>
        </p:txBody>
      </p:sp>
      <p:sp>
        <p:nvSpPr>
          <p:cNvPr id="58" name="TextBox 57"/>
          <p:cNvSpPr txBox="1"/>
          <p:nvPr/>
        </p:nvSpPr>
        <p:spPr>
          <a:xfrm rot="16200000">
            <a:off x="92240" y="3966525"/>
            <a:ext cx="10457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DHEAS production </a:t>
            </a:r>
          </a:p>
          <a:p>
            <a:pPr algn="ctr"/>
            <a:r>
              <a:rPr lang="en-US" sz="800" dirty="0" smtClean="0">
                <a:latin typeface="Arial"/>
                <a:cs typeface="Arial"/>
              </a:rPr>
              <a:t>(relative to basal)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274388" y="4611986"/>
            <a:ext cx="10720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err="1" smtClean="0">
                <a:latin typeface="Arial"/>
                <a:cs typeface="Arial"/>
              </a:rPr>
              <a:t>Kisspeptin</a:t>
            </a:r>
            <a:endParaRPr lang="en-US" sz="800" dirty="0" smtClean="0">
              <a:latin typeface="Arial"/>
              <a:cs typeface="Arial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141292" y="3228559"/>
            <a:ext cx="10079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H259R cells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031637" y="4611374"/>
            <a:ext cx="2231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/>
                <a:cs typeface="Arial"/>
              </a:rPr>
              <a:t>-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1287809" y="4611986"/>
            <a:ext cx="3842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1nM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1594659" y="4611526"/>
            <a:ext cx="44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10nM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901700" y="4611982"/>
            <a:ext cx="4983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100nM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96850" y="3176969"/>
            <a:ext cx="302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A</a:t>
            </a:r>
          </a:p>
        </p:txBody>
      </p:sp>
      <p:sp>
        <p:nvSpPr>
          <p:cNvPr id="67" name="Rectangle 66"/>
          <p:cNvSpPr/>
          <p:nvPr/>
        </p:nvSpPr>
        <p:spPr>
          <a:xfrm>
            <a:off x="1134533" y="3399367"/>
            <a:ext cx="1380067" cy="114575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cxnSp>
        <p:nvCxnSpPr>
          <p:cNvPr id="76" name="Straight Connector 75"/>
          <p:cNvCxnSpPr/>
          <p:nvPr/>
        </p:nvCxnSpPr>
        <p:spPr>
          <a:xfrm flipV="1">
            <a:off x="1151973" y="3521918"/>
            <a:ext cx="992919" cy="3406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1528924" y="3396378"/>
            <a:ext cx="2245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*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79" name="Straight Connector 78"/>
          <p:cNvCxnSpPr/>
          <p:nvPr/>
        </p:nvCxnSpPr>
        <p:spPr>
          <a:xfrm flipV="1">
            <a:off x="1144531" y="3648420"/>
            <a:ext cx="667413" cy="3405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1340310" y="3525053"/>
            <a:ext cx="2645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**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81" name="Straight Connector 80"/>
          <p:cNvCxnSpPr/>
          <p:nvPr/>
        </p:nvCxnSpPr>
        <p:spPr>
          <a:xfrm flipV="1">
            <a:off x="1479929" y="3770454"/>
            <a:ext cx="667413" cy="3405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1686393" y="3650174"/>
            <a:ext cx="2645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**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83" name="Straight Connector 82"/>
          <p:cNvCxnSpPr/>
          <p:nvPr/>
        </p:nvCxnSpPr>
        <p:spPr>
          <a:xfrm flipV="1">
            <a:off x="1487855" y="3899119"/>
            <a:ext cx="322122" cy="1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1540982" y="3774668"/>
            <a:ext cx="2245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*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92826" y="468584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D</a:t>
            </a:r>
          </a:p>
        </p:txBody>
      </p:sp>
      <p:pic>
        <p:nvPicPr>
          <p:cNvPr id="88" name="Picture 8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32508" y="5446104"/>
            <a:ext cx="1418373" cy="812171"/>
          </a:xfrm>
          <a:prstGeom prst="rect">
            <a:avLst/>
          </a:prstGeom>
        </p:spPr>
      </p:pic>
      <p:sp>
        <p:nvSpPr>
          <p:cNvPr id="89" name="TextBox 88"/>
          <p:cNvSpPr txBox="1"/>
          <p:nvPr/>
        </p:nvSpPr>
        <p:spPr>
          <a:xfrm rot="16200000">
            <a:off x="91992" y="5693313"/>
            <a:ext cx="10457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DHEAS production </a:t>
            </a:r>
          </a:p>
          <a:p>
            <a:pPr algn="ctr"/>
            <a:r>
              <a:rPr lang="en-US" sz="800" dirty="0" smtClean="0">
                <a:latin typeface="Arial"/>
                <a:cs typeface="Arial"/>
              </a:rPr>
              <a:t>(relative to basal)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273747" y="6258279"/>
            <a:ext cx="10720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err="1" smtClean="0">
                <a:latin typeface="Arial"/>
                <a:cs typeface="Arial"/>
              </a:rPr>
              <a:t>Kisspeptin</a:t>
            </a:r>
            <a:endParaRPr lang="en-US" sz="800" dirty="0" smtClean="0">
              <a:latin typeface="Arial"/>
              <a:cs typeface="Arial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1026031" y="6257667"/>
            <a:ext cx="2231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/>
                <a:cs typeface="Arial"/>
              </a:rPr>
              <a:t>-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1275853" y="6258279"/>
            <a:ext cx="3842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1nM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1576353" y="6257819"/>
            <a:ext cx="44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10nM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877044" y="6258275"/>
            <a:ext cx="4983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100nM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95" name="Straight Connector 94"/>
          <p:cNvCxnSpPr/>
          <p:nvPr/>
        </p:nvCxnSpPr>
        <p:spPr>
          <a:xfrm flipV="1">
            <a:off x="1132177" y="5502742"/>
            <a:ext cx="992919" cy="3406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1509128" y="5377202"/>
            <a:ext cx="2245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*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979776" y="5180355"/>
            <a:ext cx="12678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HFA 8-10wpc cells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734023" y="5934093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1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734953" y="5756293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2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737186" y="6105556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735013" y="5584843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3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733162" y="5410236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4</a:t>
            </a:r>
            <a:endParaRPr lang="en-US" sz="800" dirty="0">
              <a:latin typeface="Arial"/>
              <a:cs typeface="Arial"/>
            </a:endParaRPr>
          </a:p>
        </p:txBody>
      </p:sp>
      <p:pic>
        <p:nvPicPr>
          <p:cNvPr id="113" name="Picture 1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0350" y="7378735"/>
            <a:ext cx="1485900" cy="812800"/>
          </a:xfrm>
          <a:prstGeom prst="rect">
            <a:avLst/>
          </a:prstGeom>
        </p:spPr>
      </p:pic>
      <p:sp>
        <p:nvSpPr>
          <p:cNvPr id="114" name="TextBox 113"/>
          <p:cNvSpPr txBox="1"/>
          <p:nvPr/>
        </p:nvSpPr>
        <p:spPr>
          <a:xfrm>
            <a:off x="903656" y="6811727"/>
            <a:ext cx="13823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HFA 15-</a:t>
            </a:r>
            <a:r>
              <a:rPr lang="en-US" sz="800" dirty="0">
                <a:latin typeface="Arial"/>
                <a:cs typeface="Arial"/>
              </a:rPr>
              <a:t>2</a:t>
            </a:r>
            <a:r>
              <a:rPr lang="en-US" sz="800" dirty="0" smtClean="0">
                <a:latin typeface="Arial"/>
                <a:cs typeface="Arial"/>
              </a:rPr>
              <a:t>0wpc cells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026031" y="8178541"/>
            <a:ext cx="2231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/>
                <a:cs typeface="Arial"/>
              </a:rPr>
              <a:t>-</a:t>
            </a:r>
          </a:p>
        </p:txBody>
      </p:sp>
      <p:sp>
        <p:nvSpPr>
          <p:cNvPr id="116" name="TextBox 115"/>
          <p:cNvSpPr txBox="1"/>
          <p:nvPr/>
        </p:nvSpPr>
        <p:spPr>
          <a:xfrm>
            <a:off x="1275853" y="8182328"/>
            <a:ext cx="3842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1nM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576353" y="8181868"/>
            <a:ext cx="44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10nM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1877044" y="8182324"/>
            <a:ext cx="4983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100nM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277195" y="8179153"/>
            <a:ext cx="10720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err="1" smtClean="0">
                <a:latin typeface="Arial"/>
                <a:cs typeface="Arial"/>
              </a:rPr>
              <a:t>Kisspeptin</a:t>
            </a:r>
            <a:endParaRPr lang="en-US" sz="800" dirty="0" smtClean="0">
              <a:latin typeface="Arial"/>
              <a:cs typeface="Arial"/>
            </a:endParaRPr>
          </a:p>
        </p:txBody>
      </p:sp>
      <p:sp>
        <p:nvSpPr>
          <p:cNvPr id="120" name="TextBox 119"/>
          <p:cNvSpPr txBox="1"/>
          <p:nvPr/>
        </p:nvSpPr>
        <p:spPr>
          <a:xfrm rot="16200000">
            <a:off x="95167" y="7617362"/>
            <a:ext cx="10457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DHEAS production </a:t>
            </a:r>
          </a:p>
          <a:p>
            <a:pPr algn="ctr"/>
            <a:r>
              <a:rPr lang="en-US" sz="800" dirty="0" smtClean="0">
                <a:latin typeface="Arial"/>
                <a:cs typeface="Arial"/>
              </a:rPr>
              <a:t>(relative to basal)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729001" y="7853250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1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729931" y="7675450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2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732164" y="8024713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729991" y="7504000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3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731315" y="7329393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4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127" name="Straight Connector 126"/>
          <p:cNvCxnSpPr/>
          <p:nvPr/>
        </p:nvCxnSpPr>
        <p:spPr>
          <a:xfrm flipV="1">
            <a:off x="1136852" y="7156099"/>
            <a:ext cx="992919" cy="3406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1441842" y="7030559"/>
            <a:ext cx="3443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****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129" name="Straight Connector 128"/>
          <p:cNvCxnSpPr/>
          <p:nvPr/>
        </p:nvCxnSpPr>
        <p:spPr>
          <a:xfrm flipV="1">
            <a:off x="1790700" y="7419313"/>
            <a:ext cx="333724" cy="3404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0" name="TextBox 129"/>
          <p:cNvSpPr txBox="1"/>
          <p:nvPr/>
        </p:nvSpPr>
        <p:spPr>
          <a:xfrm>
            <a:off x="1596101" y="7159234"/>
            <a:ext cx="3443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****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131" name="Straight Connector 130"/>
          <p:cNvCxnSpPr/>
          <p:nvPr/>
        </p:nvCxnSpPr>
        <p:spPr>
          <a:xfrm flipV="1">
            <a:off x="1458855" y="7283985"/>
            <a:ext cx="667413" cy="3405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>
            <a:off x="1765433" y="7294702"/>
            <a:ext cx="3443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****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197098" y="5133749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B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197098" y="6760413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C</a:t>
            </a:r>
          </a:p>
        </p:txBody>
      </p:sp>
      <p:pic>
        <p:nvPicPr>
          <p:cNvPr id="138" name="Picture 137"/>
          <p:cNvPicPr>
            <a:picLocks noChangeAspect="1"/>
          </p:cNvPicPr>
          <p:nvPr/>
        </p:nvPicPr>
        <p:blipFill rotWithShape="1">
          <a:blip r:embed="rId7"/>
          <a:srcRect l="5276" b="24023"/>
          <a:stretch/>
        </p:blipFill>
        <p:spPr>
          <a:xfrm>
            <a:off x="3300802" y="3727749"/>
            <a:ext cx="1228293" cy="874825"/>
          </a:xfrm>
          <a:prstGeom prst="rect">
            <a:avLst/>
          </a:prstGeom>
        </p:spPr>
      </p:pic>
      <p:sp>
        <p:nvSpPr>
          <p:cNvPr id="139" name="TextBox 138"/>
          <p:cNvSpPr txBox="1"/>
          <p:nvPr/>
        </p:nvSpPr>
        <p:spPr>
          <a:xfrm>
            <a:off x="3410733" y="3222437"/>
            <a:ext cx="10079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H259R cells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40" name="TextBox 139"/>
          <p:cNvSpPr txBox="1"/>
          <p:nvPr/>
        </p:nvSpPr>
        <p:spPr>
          <a:xfrm rot="16200000">
            <a:off x="2414145" y="3987666"/>
            <a:ext cx="10457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DHEAS production </a:t>
            </a:r>
          </a:p>
          <a:p>
            <a:pPr algn="ctr"/>
            <a:r>
              <a:rPr lang="en-US" sz="800" dirty="0" smtClean="0">
                <a:latin typeface="Arial"/>
                <a:cs typeface="Arial"/>
              </a:rPr>
              <a:t>(relative to basal)</a:t>
            </a:r>
          </a:p>
        </p:txBody>
      </p:sp>
      <p:sp>
        <p:nvSpPr>
          <p:cNvPr id="141" name="TextBox 140"/>
          <p:cNvSpPr txBox="1"/>
          <p:nvPr/>
        </p:nvSpPr>
        <p:spPr>
          <a:xfrm>
            <a:off x="3096633" y="4447344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3096645" y="4265298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5</a:t>
            </a:r>
          </a:p>
        </p:txBody>
      </p:sp>
      <p:sp>
        <p:nvSpPr>
          <p:cNvPr id="143" name="TextBox 142"/>
          <p:cNvSpPr txBox="1"/>
          <p:nvPr/>
        </p:nvSpPr>
        <p:spPr>
          <a:xfrm>
            <a:off x="3045849" y="4071615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3047965" y="3880049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2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3049020" y="36884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25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146" name="Straight Connector 145"/>
          <p:cNvCxnSpPr/>
          <p:nvPr/>
        </p:nvCxnSpPr>
        <p:spPr>
          <a:xfrm>
            <a:off x="3628473" y="3905917"/>
            <a:ext cx="572052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0" name="TextBox 149"/>
          <p:cNvSpPr txBox="1"/>
          <p:nvPr/>
        </p:nvSpPr>
        <p:spPr>
          <a:xfrm>
            <a:off x="3797768" y="3777857"/>
            <a:ext cx="2245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*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3670870" y="4611971"/>
            <a:ext cx="10720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err="1" smtClean="0">
                <a:latin typeface="Arial"/>
                <a:cs typeface="Arial"/>
              </a:rPr>
              <a:t>Kisspeptin</a:t>
            </a:r>
            <a:endParaRPr lang="en-US" sz="800" dirty="0" smtClean="0">
              <a:latin typeface="Arial"/>
              <a:cs typeface="Arial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3090412" y="4611911"/>
            <a:ext cx="10720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Untreated</a:t>
            </a:r>
          </a:p>
        </p:txBody>
      </p:sp>
      <p:sp>
        <p:nvSpPr>
          <p:cNvPr id="154" name="TextBox 153"/>
          <p:cNvSpPr txBox="1"/>
          <p:nvPr/>
        </p:nvSpPr>
        <p:spPr>
          <a:xfrm>
            <a:off x="2619375" y="3180502"/>
            <a:ext cx="287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Arial"/>
                <a:cs typeface="Arial"/>
              </a:rPr>
              <a:t>E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2618837" y="5138739"/>
            <a:ext cx="278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 smtClean="0">
                <a:latin typeface="Arial"/>
                <a:cs typeface="Arial"/>
              </a:rPr>
              <a:t>F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3354315" y="5189539"/>
            <a:ext cx="13060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HFA 8-10wpc cells</a:t>
            </a:r>
            <a:endParaRPr lang="en-US" sz="800" dirty="0">
              <a:latin typeface="Arial"/>
              <a:cs typeface="Arial"/>
            </a:endParaRPr>
          </a:p>
        </p:txBody>
      </p:sp>
      <p:pic>
        <p:nvPicPr>
          <p:cNvPr id="157" name="Picture 156"/>
          <p:cNvPicPr>
            <a:picLocks noChangeAspect="1"/>
          </p:cNvPicPr>
          <p:nvPr/>
        </p:nvPicPr>
        <p:blipFill rotWithShape="1">
          <a:blip r:embed="rId8"/>
          <a:srcRect l="7820" b="22878"/>
          <a:stretch/>
        </p:blipFill>
        <p:spPr>
          <a:xfrm>
            <a:off x="3300802" y="5363294"/>
            <a:ext cx="1225324" cy="888299"/>
          </a:xfrm>
          <a:prstGeom prst="rect">
            <a:avLst/>
          </a:prstGeom>
        </p:spPr>
      </p:pic>
      <p:sp>
        <p:nvSpPr>
          <p:cNvPr id="158" name="TextBox 157"/>
          <p:cNvSpPr txBox="1"/>
          <p:nvPr/>
        </p:nvSpPr>
        <p:spPr>
          <a:xfrm rot="16200000">
            <a:off x="2415165" y="5631547"/>
            <a:ext cx="10457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DHEAS production </a:t>
            </a:r>
          </a:p>
          <a:p>
            <a:pPr algn="ctr"/>
            <a:r>
              <a:rPr lang="en-US" sz="800" dirty="0" smtClean="0">
                <a:latin typeface="Arial"/>
                <a:cs typeface="Arial"/>
              </a:rPr>
              <a:t>(relative to basal)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3088845" y="6258020"/>
            <a:ext cx="10720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Arial"/>
                <a:cs typeface="Arial"/>
              </a:rPr>
              <a:t>Untreated</a:t>
            </a:r>
          </a:p>
        </p:txBody>
      </p:sp>
      <p:sp>
        <p:nvSpPr>
          <p:cNvPr id="160" name="TextBox 159"/>
          <p:cNvSpPr txBox="1"/>
          <p:nvPr/>
        </p:nvSpPr>
        <p:spPr>
          <a:xfrm>
            <a:off x="3664520" y="6256975"/>
            <a:ext cx="10720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err="1" smtClean="0">
                <a:latin typeface="Arial"/>
                <a:cs typeface="Arial"/>
              </a:rPr>
              <a:t>Kisspeptin</a:t>
            </a:r>
            <a:endParaRPr lang="en-US" sz="800" dirty="0" smtClean="0">
              <a:latin typeface="Arial"/>
              <a:cs typeface="Arial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3089635" y="6094869"/>
            <a:ext cx="2417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3045875" y="5901212"/>
            <a:ext cx="29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5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2997123" y="5710940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0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2993452" y="5515449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150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2993537" y="5328857"/>
            <a:ext cx="355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200</a:t>
            </a:r>
            <a:endParaRPr lang="en-US" sz="800" dirty="0">
              <a:latin typeface="Arial"/>
              <a:cs typeface="Arial"/>
            </a:endParaRPr>
          </a:p>
        </p:txBody>
      </p:sp>
      <p:cxnSp>
        <p:nvCxnSpPr>
          <p:cNvPr id="166" name="Straight Connector 165"/>
          <p:cNvCxnSpPr/>
          <p:nvPr/>
        </p:nvCxnSpPr>
        <p:spPr>
          <a:xfrm>
            <a:off x="3626042" y="5531398"/>
            <a:ext cx="572052" cy="0"/>
          </a:xfrm>
          <a:prstGeom prst="line">
            <a:avLst/>
          </a:prstGeom>
          <a:ln w="63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7" name="TextBox 166"/>
          <p:cNvSpPr txBox="1"/>
          <p:nvPr/>
        </p:nvSpPr>
        <p:spPr>
          <a:xfrm>
            <a:off x="3795337" y="5403338"/>
            <a:ext cx="2245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*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155973" y="127000"/>
            <a:ext cx="1834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Supplemental Figure </a:t>
            </a:r>
            <a:r>
              <a:rPr lang="en-US" sz="1200" b="1" dirty="0">
                <a:latin typeface="Arial"/>
                <a:cs typeface="Arial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8180506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35</TotalTime>
  <Words>143</Words>
  <Application>Microsoft Macintosh PowerPoint</Application>
  <PresentationFormat>Custom</PresentationFormat>
  <Paragraphs>8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SHINI KATUGAMPOLA</dc:creator>
  <cp:lastModifiedBy>Helen Storr</cp:lastModifiedBy>
  <cp:revision>101</cp:revision>
  <dcterms:created xsi:type="dcterms:W3CDTF">2017-05-16T12:56:18Z</dcterms:created>
  <dcterms:modified xsi:type="dcterms:W3CDTF">2017-06-02T10:43:21Z</dcterms:modified>
</cp:coreProperties>
</file>